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4694"/>
  </p:normalViewPr>
  <p:slideViewPr>
    <p:cSldViewPr snapToGrid="0" snapToObjects="1">
      <p:cViewPr>
        <p:scale>
          <a:sx n="63" d="100"/>
          <a:sy n="63" d="100"/>
        </p:scale>
        <p:origin x="-2232" y="48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7127F-7536-5343-BA4B-DCBB343C05E6}" type="datetimeFigureOut">
              <a:rPr lang="en-US" smtClean="0"/>
              <a:t>19/1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8BEB2B-6736-8D41-9549-ABF4E7714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59939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7127F-7536-5343-BA4B-DCBB343C05E6}" type="datetimeFigureOut">
              <a:rPr lang="en-US" smtClean="0"/>
              <a:t>19/1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8BEB2B-6736-8D41-9549-ABF4E7714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91507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7127F-7536-5343-BA4B-DCBB343C05E6}" type="datetimeFigureOut">
              <a:rPr lang="en-US" smtClean="0"/>
              <a:t>19/1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8BEB2B-6736-8D41-9549-ABF4E7714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9300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7127F-7536-5343-BA4B-DCBB343C05E6}" type="datetimeFigureOut">
              <a:rPr lang="en-US" smtClean="0"/>
              <a:t>19/1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8BEB2B-6736-8D41-9549-ABF4E7714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14494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7127F-7536-5343-BA4B-DCBB343C05E6}" type="datetimeFigureOut">
              <a:rPr lang="en-US" smtClean="0"/>
              <a:t>19/1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8BEB2B-6736-8D41-9549-ABF4E7714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55830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7127F-7536-5343-BA4B-DCBB343C05E6}" type="datetimeFigureOut">
              <a:rPr lang="en-US" smtClean="0"/>
              <a:t>19/1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8BEB2B-6736-8D41-9549-ABF4E7714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89625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7127F-7536-5343-BA4B-DCBB343C05E6}" type="datetimeFigureOut">
              <a:rPr lang="en-US" smtClean="0"/>
              <a:t>19/11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8BEB2B-6736-8D41-9549-ABF4E7714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49514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7127F-7536-5343-BA4B-DCBB343C05E6}" type="datetimeFigureOut">
              <a:rPr lang="en-US" smtClean="0"/>
              <a:t>19/11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8BEB2B-6736-8D41-9549-ABF4E7714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43687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7127F-7536-5343-BA4B-DCBB343C05E6}" type="datetimeFigureOut">
              <a:rPr lang="en-US" smtClean="0"/>
              <a:t>19/11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8BEB2B-6736-8D41-9549-ABF4E7714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81604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7127F-7536-5343-BA4B-DCBB343C05E6}" type="datetimeFigureOut">
              <a:rPr lang="en-US" smtClean="0"/>
              <a:t>19/1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8BEB2B-6736-8D41-9549-ABF4E7714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48765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7127F-7536-5343-BA4B-DCBB343C05E6}" type="datetimeFigureOut">
              <a:rPr lang="en-US" smtClean="0"/>
              <a:t>19/1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8BEB2B-6736-8D41-9549-ABF4E7714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19221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7127F-7536-5343-BA4B-DCBB343C05E6}" type="datetimeFigureOut">
              <a:rPr lang="en-US" smtClean="0"/>
              <a:t>19/1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8BEB2B-6736-8D41-9549-ABF4E7714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21659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Obraz 14">
            <a:extLst>
              <a:ext uri="{FF2B5EF4-FFF2-40B4-BE49-F238E27FC236}">
                <a16:creationId xmlns:a16="http://schemas.microsoft.com/office/drawing/2014/main" xmlns="" id="{BEEE00EB-1C8E-CE44-A6C7-99926F84EABE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90725" y="1295400"/>
            <a:ext cx="2876550" cy="5029200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xmlns="" id="{DABCF226-9A31-7546-BDA7-F7CB201F83DF}"/>
              </a:ext>
            </a:extLst>
          </p:cNvPr>
          <p:cNvSpPr/>
          <p:nvPr/>
        </p:nvSpPr>
        <p:spPr>
          <a:xfrm>
            <a:off x="571500" y="6590186"/>
            <a:ext cx="6115050" cy="10410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3. Single cell traces from sagittal SFO recordings.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amples of single </a:t>
            </a:r>
            <a:r>
              <a:rPr lang="en-US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ll PER2::LUC bioluminescence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races </a:t>
            </a:r>
            <a:r>
              <a:rPr lang="en-US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corded from</a:t>
            </a:r>
            <a:r>
              <a:rPr lang="en-US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 sagittal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FO </a:t>
            </a:r>
            <a:r>
              <a:rPr lang="en-US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rain slice</a:t>
            </a:r>
            <a:r>
              <a:rPr lang="en-US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US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583720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0</TotalTime>
  <Words>30</Words>
  <Application>Microsoft Macintosh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gh Piggins</dc:creator>
  <cp:lastModifiedBy>Hugh Piggins</cp:lastModifiedBy>
  <cp:revision>3</cp:revision>
  <dcterms:created xsi:type="dcterms:W3CDTF">2019-09-19T09:24:18Z</dcterms:created>
  <dcterms:modified xsi:type="dcterms:W3CDTF">2019-11-19T21:18:09Z</dcterms:modified>
</cp:coreProperties>
</file>